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60" r:id="rId3"/>
    <p:sldId id="256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37"/>
    <p:restoredTop sz="89052"/>
  </p:normalViewPr>
  <p:slideViewPr>
    <p:cSldViewPr snapToGrid="0" snapToObjects="1">
      <p:cViewPr varScale="1">
        <p:scale>
          <a:sx n="93" d="100"/>
          <a:sy n="93" d="100"/>
        </p:scale>
        <p:origin x="98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EC2211-0FFD-8445-A668-8CC81CAD9FDE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FFE06C-DC6C-6440-8010-3E9A6CF23D8D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Read length distribution of HiFi reads (A). Read quality value distribution of HiFi reads (B)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FFE06C-DC6C-6440-8010-3E9A6CF23D8D}" type="slidenum">
              <a:rPr lang="en-US" smtClean="0"/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Sequencing depth distribution for the YY5 v1.0 genome assembly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FFE06C-DC6C-6440-8010-3E9A6CF23D8D}" type="slidenum">
              <a:rPr lang="en-US" smtClean="0"/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The evaluation for  the YY5 v2.0 and CDC Bethune v2 genome assemblies using BUSCO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FFE06C-DC6C-6440-8010-3E9A6CF23D8D}" type="slidenum">
              <a:rPr lang="en-US" smtClean="0"/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58F800-7530-2B42-99D2-C056AA0CB90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328C4-03EC-924E-8461-6FDD92857D54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08043" y="1220676"/>
            <a:ext cx="4424996" cy="44166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5952" y="1220676"/>
            <a:ext cx="5964660" cy="441664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29139" y="1151401"/>
            <a:ext cx="497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467972" y="1151401"/>
            <a:ext cx="497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38400" y="685800"/>
            <a:ext cx="7315200" cy="54864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732584" y="6172200"/>
            <a:ext cx="1075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th (x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198076" y="3026713"/>
            <a:ext cx="461665" cy="63094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82850" y="850900"/>
            <a:ext cx="7226300" cy="51562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11454" y="1881555"/>
            <a:ext cx="192766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YY5 v2.0 genom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609745" y="2825261"/>
            <a:ext cx="181552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YY5 v2.0 protein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44062" y="3768967"/>
            <a:ext cx="256735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 Bethune v2 genom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7067" y="4642336"/>
            <a:ext cx="24943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 Bethune v2 protein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WPS 演示</Application>
  <PresentationFormat>Widescreen</PresentationFormat>
  <Paragraphs>16</Paragraphs>
  <Slides>3</Slides>
  <Notes>5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微软雅黑</vt:lpstr>
      <vt:lpstr>Arial Unicode MS</vt:lpstr>
      <vt:lpstr>Calibri Light</vt:lpstr>
      <vt:lpstr>Calibri</vt:lpstr>
      <vt:lpstr>等线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 Fu</dc:creator>
  <cp:lastModifiedBy>萨如拉</cp:lastModifiedBy>
  <cp:revision>48</cp:revision>
  <dcterms:created xsi:type="dcterms:W3CDTF">2021-04-10T08:24:00Z</dcterms:created>
  <dcterms:modified xsi:type="dcterms:W3CDTF">2021-07-03T03:27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98</vt:lpwstr>
  </property>
</Properties>
</file>